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22860000" cy="3108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792" userDrawn="1">
          <p15:clr>
            <a:srgbClr val="A4A3A4"/>
          </p15:clr>
        </p15:guide>
        <p15:guide id="2" pos="720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KA(" userId="S::kaynakat@ucmail.uc.edu::e30822f5-f881-493f-bf88-3d523b0e27a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ynak, Ahmet (kaynakat)" initials="KA(" lastIdx="9" clrIdx="0">
    <p:extLst>
      <p:ext uri="{19B8F6BF-5375-455C-9EA6-DF929625EA0E}">
        <p15:presenceInfo xmlns:p15="http://schemas.microsoft.com/office/powerpoint/2012/main" userId="S::kaynakat@mail.uc.edu::e30822f5-f881-493f-bf88-3d523b0e27a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486F0B-2582-4A8A-8B94-41E9209DC5F9}" v="11" dt="2025-01-13T15:57:03.5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6973" autoAdjust="0"/>
  </p:normalViewPr>
  <p:slideViewPr>
    <p:cSldViewPr snapToGrid="0">
      <p:cViewPr>
        <p:scale>
          <a:sx n="50" d="100"/>
          <a:sy n="50" d="100"/>
        </p:scale>
        <p:origin x="2484" y="-1500"/>
      </p:cViewPr>
      <p:guideLst>
        <p:guide orient="horz" pos="9792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21486F0B-2582-4A8A-8B94-41E9209DC5F9}"/>
    <pc:docChg chg="modSld">
      <pc:chgData name="Kaynak, Ahmet (kaynakat)" userId="e30822f5-f881-493f-bf88-3d523b0e27a6" providerId="ADAL" clId="{21486F0B-2582-4A8A-8B94-41E9209DC5F9}" dt="2025-01-27T17:21:13.262" v="165" actId="113"/>
      <pc:docMkLst>
        <pc:docMk/>
      </pc:docMkLst>
      <pc:sldChg chg="addSp delSp modSp mod">
        <pc:chgData name="Kaynak, Ahmet (kaynakat)" userId="e30822f5-f881-493f-bf88-3d523b0e27a6" providerId="ADAL" clId="{21486F0B-2582-4A8A-8B94-41E9209DC5F9}" dt="2025-01-27T17:21:13.262" v="165" actId="113"/>
        <pc:sldMkLst>
          <pc:docMk/>
          <pc:sldMk cId="2921408782" sldId="260"/>
        </pc:sldMkLst>
        <pc:spChg chg="mod">
          <ac:chgData name="Kaynak, Ahmet (kaynakat)" userId="e30822f5-f881-493f-bf88-3d523b0e27a6" providerId="ADAL" clId="{21486F0B-2582-4A8A-8B94-41E9209DC5F9}" dt="2025-01-27T17:21:13.262" v="165" actId="113"/>
          <ac:spMkLst>
            <pc:docMk/>
            <pc:sldMk cId="2921408782" sldId="260"/>
            <ac:spMk id="121" creationId="{8E9B825B-84B8-3E30-1ADB-D2101761C3FD}"/>
          </ac:spMkLst>
        </pc:spChg>
        <pc:graphicFrameChg chg="add mod">
          <ac:chgData name="Kaynak, Ahmet (kaynakat)" userId="e30822f5-f881-493f-bf88-3d523b0e27a6" providerId="ADAL" clId="{21486F0B-2582-4A8A-8B94-41E9209DC5F9}" dt="2025-01-13T15:57:03.543" v="14"/>
          <ac:graphicFrameMkLst>
            <pc:docMk/>
            <pc:sldMk cId="2921408782" sldId="260"/>
            <ac:graphicFrameMk id="4" creationId="{A80ECE98-AF47-F4CD-6C83-5DA873A51D9F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D8B76-510C-5840-AFF8-56732EE74642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43000"/>
            <a:ext cx="2270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0FCF20-DC62-4C47-927D-B0873A9B0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1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5088045"/>
            <a:ext cx="19431000" cy="10823787"/>
          </a:xfrm>
        </p:spPr>
        <p:txBody>
          <a:bodyPr anchor="b"/>
          <a:lstStyle>
            <a:lvl1pPr algn="ctr"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16329239"/>
            <a:ext cx="17145000" cy="7506121"/>
          </a:xfrm>
        </p:spPr>
        <p:txBody>
          <a:bodyPr/>
          <a:lstStyle>
            <a:lvl1pPr marL="0" indent="0" algn="ctr">
              <a:buNone/>
              <a:defRPr sz="6000"/>
            </a:lvl1pPr>
            <a:lvl2pPr marL="1143000" indent="0" algn="ctr">
              <a:buNone/>
              <a:defRPr sz="5000"/>
            </a:lvl2pPr>
            <a:lvl3pPr marL="2286000" indent="0" algn="ctr">
              <a:buNone/>
              <a:defRPr sz="4500"/>
            </a:lvl3pPr>
            <a:lvl4pPr marL="3429000" indent="0" algn="ctr">
              <a:buNone/>
              <a:defRPr sz="4000"/>
            </a:lvl4pPr>
            <a:lvl5pPr marL="4572000" indent="0" algn="ctr">
              <a:buNone/>
              <a:defRPr sz="4000"/>
            </a:lvl5pPr>
            <a:lvl6pPr marL="5715000" indent="0" algn="ctr">
              <a:buNone/>
              <a:defRPr sz="4000"/>
            </a:lvl6pPr>
            <a:lvl7pPr marL="6858000" indent="0" algn="ctr">
              <a:buNone/>
              <a:defRPr sz="4000"/>
            </a:lvl7pPr>
            <a:lvl8pPr marL="8001000" indent="0" algn="ctr">
              <a:buNone/>
              <a:defRPr sz="4000"/>
            </a:lvl8pPr>
            <a:lvl9pPr marL="9144000" indent="0" algn="ctr">
              <a:buNone/>
              <a:defRPr sz="4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3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688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9" y="1655233"/>
            <a:ext cx="4929188" cy="263469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6" y="1655233"/>
            <a:ext cx="14501813" cy="263469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97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77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20" y="7750819"/>
            <a:ext cx="19716750" cy="12932408"/>
          </a:xfrm>
        </p:spPr>
        <p:txBody>
          <a:bodyPr anchor="b"/>
          <a:lstStyle>
            <a:lvl1pPr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20" y="20805572"/>
            <a:ext cx="19716750" cy="6800848"/>
          </a:xfrm>
        </p:spPr>
        <p:txBody>
          <a:bodyPr/>
          <a:lstStyle>
            <a:lvl1pPr marL="0" indent="0">
              <a:buNone/>
              <a:defRPr sz="6000">
                <a:solidFill>
                  <a:schemeClr val="tx1"/>
                </a:solidFill>
              </a:defRPr>
            </a:lvl1pPr>
            <a:lvl2pPr marL="1143000" indent="0">
              <a:buNone/>
              <a:defRPr sz="5000">
                <a:solidFill>
                  <a:schemeClr val="tx1">
                    <a:tint val="75000"/>
                  </a:schemeClr>
                </a:solidFill>
              </a:defRPr>
            </a:lvl2pPr>
            <a:lvl3pPr marL="22860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429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4572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5715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6858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8001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9144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06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655240"/>
            <a:ext cx="19716750" cy="600921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5" y="7621272"/>
            <a:ext cx="9670850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5" y="11356340"/>
            <a:ext cx="9670850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6" y="7621272"/>
            <a:ext cx="9718478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6" y="11356340"/>
            <a:ext cx="9718478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962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109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473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4476333"/>
            <a:ext cx="11572875" cy="22093767"/>
          </a:xfrm>
        </p:spPr>
        <p:txBody>
          <a:bodyPr/>
          <a:lstStyle>
            <a:lvl1pPr>
              <a:defRPr sz="8000"/>
            </a:lvl1pPr>
            <a:lvl2pPr>
              <a:defRPr sz="7000"/>
            </a:lvl2pPr>
            <a:lvl3pPr>
              <a:defRPr sz="6000"/>
            </a:lvl3pPr>
            <a:lvl4pPr>
              <a:defRPr sz="5000"/>
            </a:lvl4pPr>
            <a:lvl5pPr>
              <a:defRPr sz="5000"/>
            </a:lvl5pPr>
            <a:lvl6pPr>
              <a:defRPr sz="5000"/>
            </a:lvl6pPr>
            <a:lvl7pPr>
              <a:defRPr sz="5000"/>
            </a:lvl7pPr>
            <a:lvl8pPr>
              <a:defRPr sz="5000"/>
            </a:lvl8pPr>
            <a:lvl9pPr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858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4476333"/>
            <a:ext cx="11572875" cy="22093767"/>
          </a:xfrm>
        </p:spPr>
        <p:txBody>
          <a:bodyPr anchor="t"/>
          <a:lstStyle>
            <a:lvl1pPr marL="0" indent="0">
              <a:buNone/>
              <a:defRPr sz="8000"/>
            </a:lvl1pPr>
            <a:lvl2pPr marL="1143000" indent="0">
              <a:buNone/>
              <a:defRPr sz="7000"/>
            </a:lvl2pPr>
            <a:lvl3pPr marL="2286000" indent="0">
              <a:buNone/>
              <a:defRPr sz="6000"/>
            </a:lvl3pPr>
            <a:lvl4pPr marL="3429000" indent="0">
              <a:buNone/>
              <a:defRPr sz="5000"/>
            </a:lvl4pPr>
            <a:lvl5pPr marL="4572000" indent="0">
              <a:buNone/>
              <a:defRPr sz="5000"/>
            </a:lvl5pPr>
            <a:lvl6pPr marL="5715000" indent="0">
              <a:buNone/>
              <a:defRPr sz="5000"/>
            </a:lvl6pPr>
            <a:lvl7pPr marL="6858000" indent="0">
              <a:buNone/>
              <a:defRPr sz="5000"/>
            </a:lvl7pPr>
            <a:lvl8pPr marL="8001000" indent="0">
              <a:buNone/>
              <a:defRPr sz="5000"/>
            </a:lvl8pPr>
            <a:lvl9pPr marL="9144000" indent="0">
              <a:buNone/>
              <a:defRPr sz="5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87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1655240"/>
            <a:ext cx="19716750" cy="600921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8276166"/>
            <a:ext cx="19716750" cy="197260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28815460"/>
            <a:ext cx="771525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2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286000" rtl="0" eaLnBrk="1" latinLnBrk="0" hangingPunct="1">
        <a:lnSpc>
          <a:spcPct val="90000"/>
        </a:lnSpc>
        <a:spcBef>
          <a:spcPct val="0"/>
        </a:spcBef>
        <a:buNone/>
        <a:defRPr sz="1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1500" indent="-571500" algn="l" defTabSz="2286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1pPr>
      <a:lvl2pPr marL="1714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857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4000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6286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7429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572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715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143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572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15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858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001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144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png"/><Relationship Id="rId7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788739-5E7B-096F-29B7-064A25B643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TextBox 120">
            <a:extLst>
              <a:ext uri="{FF2B5EF4-FFF2-40B4-BE49-F238E27FC236}">
                <a16:creationId xmlns:a16="http://schemas.microsoft.com/office/drawing/2014/main" id="{8E9B825B-84B8-3E30-1ADB-D2101761C3FD}"/>
              </a:ext>
            </a:extLst>
          </p:cNvPr>
          <p:cNvSpPr txBox="1"/>
          <p:nvPr/>
        </p:nvSpPr>
        <p:spPr>
          <a:xfrm>
            <a:off x="476480" y="24799133"/>
            <a:ext cx="22084484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1: 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ancer cell </a:t>
            </a:r>
            <a:r>
              <a:rPr lang="en-US" sz="28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MD-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M induces M</a:t>
            </a:r>
            <a:r>
              <a:rPr lang="el-GR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2 polarization.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low cytometric measurement of CD14 in response to PMA and DMEM.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sz="28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low cytometric measurement of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D163 and CD206 in HMDM in response to M1 polarizing IFNϒ, M2 polarizing IL-4 and IL-13 and Gli36 EMD-CM.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low cytometric measurement of MØ M2 markers, CD206 and CD301 in mouse J774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 in response to DMEM and Gli36 EMD-CM. 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B451524-0F95-0645-3EA7-04217D7BEAFB}"/>
              </a:ext>
            </a:extLst>
          </p:cNvPr>
          <p:cNvGrpSpPr/>
          <p:nvPr/>
        </p:nvGrpSpPr>
        <p:grpSpPr>
          <a:xfrm>
            <a:off x="7704346" y="8754417"/>
            <a:ext cx="14014655" cy="5824199"/>
            <a:chOff x="4256524" y="19004480"/>
            <a:chExt cx="14014655" cy="5824199"/>
          </a:xfrm>
        </p:grpSpPr>
        <p:pic>
          <p:nvPicPr>
            <p:cNvPr id="75" name="Picture 74" descr="Chart, scatter chart&#10;&#10;Description automatically generated">
              <a:extLst>
                <a:ext uri="{FF2B5EF4-FFF2-40B4-BE49-F238E27FC236}">
                  <a16:creationId xmlns:a16="http://schemas.microsoft.com/office/drawing/2014/main" id="{968FE99B-EF5A-B8C9-CE2F-F57C7615A3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247773" y="22615693"/>
              <a:ext cx="2274566" cy="1700800"/>
            </a:xfrm>
            <a:prstGeom prst="rect">
              <a:avLst/>
            </a:prstGeom>
          </p:spPr>
        </p:pic>
        <p:pic>
          <p:nvPicPr>
            <p:cNvPr id="76" name="Picture 75" descr="Chart, scatter chart&#10;&#10;Description automatically generated">
              <a:extLst>
                <a:ext uri="{FF2B5EF4-FFF2-40B4-BE49-F238E27FC236}">
                  <a16:creationId xmlns:a16="http://schemas.microsoft.com/office/drawing/2014/main" id="{204151E1-CEDD-4A9E-0FBB-29E22B42A6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264689" y="20796463"/>
              <a:ext cx="2240735" cy="1700800"/>
            </a:xfrm>
            <a:prstGeom prst="rect">
              <a:avLst/>
            </a:prstGeom>
          </p:spPr>
        </p:pic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0DA05CF5-3DEB-967D-75CF-D8EC44861A58}"/>
                </a:ext>
              </a:extLst>
            </p:cNvPr>
            <p:cNvSpPr txBox="1"/>
            <p:nvPr/>
          </p:nvSpPr>
          <p:spPr>
            <a:xfrm>
              <a:off x="15184054" y="20796944"/>
              <a:ext cx="120417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7.8%</a:t>
              </a:r>
            </a:p>
          </p:txBody>
        </p:sp>
        <p:cxnSp>
          <p:nvCxnSpPr>
            <p:cNvPr id="129" name="Straight Arrow Connector 128">
              <a:extLst>
                <a:ext uri="{FF2B5EF4-FFF2-40B4-BE49-F238E27FC236}">
                  <a16:creationId xmlns:a16="http://schemas.microsoft.com/office/drawing/2014/main" id="{E0C08212-1621-9CE1-A182-BC8AF50197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968117" y="24581039"/>
              <a:ext cx="1521313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1E79DB42-F268-037E-B3B4-CDFA68FCD43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995060" y="22012312"/>
              <a:ext cx="0" cy="258105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5930C77E-45A0-08BA-12EF-96E53DBCDA5C}"/>
                </a:ext>
              </a:extLst>
            </p:cNvPr>
            <p:cNvSpPr txBox="1"/>
            <p:nvPr/>
          </p:nvSpPr>
          <p:spPr>
            <a:xfrm rot="16200000">
              <a:off x="13345407" y="21004831"/>
              <a:ext cx="13051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E21C1531-E9D6-7650-49D1-DE3031FA12F9}"/>
                </a:ext>
              </a:extLst>
            </p:cNvPr>
            <p:cNvSpPr txBox="1"/>
            <p:nvPr/>
          </p:nvSpPr>
          <p:spPr>
            <a:xfrm>
              <a:off x="15579591" y="24305459"/>
              <a:ext cx="13051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301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FE2FE40-307D-0B62-B1F7-D3E3C76AAFB8}"/>
                </a:ext>
              </a:extLst>
            </p:cNvPr>
            <p:cNvSpPr txBox="1"/>
            <p:nvPr/>
          </p:nvSpPr>
          <p:spPr>
            <a:xfrm>
              <a:off x="15165296" y="22614571"/>
              <a:ext cx="130356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44.5 %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67C7D0C-4736-CC4A-2F7D-ED48284DAC31}"/>
                </a:ext>
              </a:extLst>
            </p:cNvPr>
            <p:cNvSpPr txBox="1"/>
            <p:nvPr/>
          </p:nvSpPr>
          <p:spPr>
            <a:xfrm>
              <a:off x="16467333" y="21482338"/>
              <a:ext cx="1282723" cy="523220"/>
            </a:xfrm>
            <a:prstGeom prst="rect">
              <a:avLst/>
            </a:prstGeom>
            <a:noFill/>
          </p:spPr>
          <p:txBody>
            <a:bodyPr wrap="none" rtlCol="0" anchor="b" anchorCtr="1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DMEM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B13A8D78-42A2-60B1-FA46-EBF59E6AF8B7}"/>
                </a:ext>
              </a:extLst>
            </p:cNvPr>
            <p:cNvSpPr txBox="1"/>
            <p:nvPr/>
          </p:nvSpPr>
          <p:spPr>
            <a:xfrm>
              <a:off x="16608544" y="22825785"/>
              <a:ext cx="1662635" cy="954107"/>
            </a:xfrm>
            <a:prstGeom prst="rect">
              <a:avLst/>
            </a:prstGeom>
            <a:noFill/>
          </p:spPr>
          <p:txBody>
            <a:bodyPr wrap="none" rtlCol="0" anchor="b" anchorCtr="1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Gli36 </a:t>
              </a:r>
            </a:p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EMD-CM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A6249CF6-5C21-9099-C465-21AC1530D87C}"/>
                </a:ext>
              </a:extLst>
            </p:cNvPr>
            <p:cNvSpPr txBox="1"/>
            <p:nvPr/>
          </p:nvSpPr>
          <p:spPr>
            <a:xfrm>
              <a:off x="13736379" y="19366501"/>
              <a:ext cx="301877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Mouse J774 M</a:t>
              </a:r>
              <a:r>
                <a:rPr lang="en-US" sz="2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+mn-ea"/>
                </a:rPr>
                <a:t>Φ</a:t>
              </a:r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pic>
          <p:nvPicPr>
            <p:cNvPr id="139" name="Picture 138" descr="Chart, scatter chart&#10;&#10;Description automatically generated">
              <a:extLst>
                <a:ext uri="{FF2B5EF4-FFF2-40B4-BE49-F238E27FC236}">
                  <a16:creationId xmlns:a16="http://schemas.microsoft.com/office/drawing/2014/main" id="{A45ED092-9504-8784-3777-1A74415A714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087142" y="20939624"/>
              <a:ext cx="2223249" cy="1811045"/>
            </a:xfrm>
            <a:prstGeom prst="rect">
              <a:avLst/>
            </a:prstGeom>
          </p:spPr>
        </p:pic>
        <p:pic>
          <p:nvPicPr>
            <p:cNvPr id="141" name="Picture 140" descr="Chart, scatter chart&#10;&#10;Description automatically generated">
              <a:extLst>
                <a:ext uri="{FF2B5EF4-FFF2-40B4-BE49-F238E27FC236}">
                  <a16:creationId xmlns:a16="http://schemas.microsoft.com/office/drawing/2014/main" id="{3D0DEC16-1847-720E-6C58-F4D6D76B6A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494570" y="20939624"/>
              <a:ext cx="2197940" cy="1780505"/>
            </a:xfrm>
            <a:prstGeom prst="rect">
              <a:avLst/>
            </a:prstGeom>
          </p:spPr>
        </p:pic>
        <p:pic>
          <p:nvPicPr>
            <p:cNvPr id="142" name="Picture 141" descr="Chart, scatter chart&#10;&#10;Description automatically generated">
              <a:extLst>
                <a:ext uri="{FF2B5EF4-FFF2-40B4-BE49-F238E27FC236}">
                  <a16:creationId xmlns:a16="http://schemas.microsoft.com/office/drawing/2014/main" id="{C638B63C-89C5-6F17-8BF4-F4FB493652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05835" y="20928589"/>
              <a:ext cx="2206739" cy="1787352"/>
            </a:xfrm>
            <a:prstGeom prst="rect">
              <a:avLst/>
            </a:prstGeom>
          </p:spPr>
        </p:pic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194E60D8-EA6B-47C7-F2A2-CA5099E826BC}"/>
                </a:ext>
              </a:extLst>
            </p:cNvPr>
            <p:cNvGrpSpPr/>
            <p:nvPr/>
          </p:nvGrpSpPr>
          <p:grpSpPr>
            <a:xfrm>
              <a:off x="5445447" y="20061561"/>
              <a:ext cx="7377295" cy="1370791"/>
              <a:chOff x="1372525" y="401830"/>
              <a:chExt cx="3078766" cy="443683"/>
            </a:xfrm>
          </p:grpSpPr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A7AC4C48-D06A-8B15-7657-2D5A5FC0428A}"/>
                  </a:ext>
                </a:extLst>
              </p:cNvPr>
              <p:cNvSpPr txBox="1"/>
              <p:nvPr/>
            </p:nvSpPr>
            <p:spPr>
              <a:xfrm>
                <a:off x="3266392" y="401830"/>
                <a:ext cx="1184899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i36 EMD-CM  </a:t>
                </a: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D9B7E482-9674-FDCD-5B61-37C37DE23BE3}"/>
                  </a:ext>
                </a:extLst>
              </p:cNvPr>
              <p:cNvSpPr txBox="1"/>
              <p:nvPr/>
            </p:nvSpPr>
            <p:spPr>
              <a:xfrm>
                <a:off x="3692405" y="676163"/>
                <a:ext cx="502539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6.9%</a:t>
                </a:r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AA526CB8-ECD7-0057-9D5D-CDAD1B5C3A84}"/>
                  </a:ext>
                </a:extLst>
              </p:cNvPr>
              <p:cNvSpPr txBox="1"/>
              <p:nvPr/>
            </p:nvSpPr>
            <p:spPr>
              <a:xfrm>
                <a:off x="1422717" y="672314"/>
                <a:ext cx="502539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9.4%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509208E3-F1B5-B6D2-F640-D2B9C46969B4}"/>
                  </a:ext>
                </a:extLst>
              </p:cNvPr>
              <p:cNvSpPr txBox="1"/>
              <p:nvPr/>
            </p:nvSpPr>
            <p:spPr>
              <a:xfrm>
                <a:off x="2374869" y="415123"/>
                <a:ext cx="681826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L4+IL13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C403C669-1309-E4A6-F367-49F73AB8BD11}"/>
                  </a:ext>
                </a:extLst>
              </p:cNvPr>
              <p:cNvSpPr txBox="1"/>
              <p:nvPr/>
            </p:nvSpPr>
            <p:spPr>
              <a:xfrm>
                <a:off x="2600822" y="672314"/>
                <a:ext cx="502539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6.7%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3FD80E7F-63B3-9D53-DB42-A75C92088B0A}"/>
                  </a:ext>
                </a:extLst>
              </p:cNvPr>
              <p:cNvSpPr txBox="1"/>
              <p:nvPr/>
            </p:nvSpPr>
            <p:spPr>
              <a:xfrm>
                <a:off x="1372525" y="415123"/>
                <a:ext cx="414233" cy="1693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 </a:t>
                </a:r>
                <a:r>
                  <a:rPr lang="el-GR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ᵞ</a:t>
                </a:r>
                <a:endParaRPr 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5B9DF61D-701D-B7D3-5A66-C84885FF0E43}"/>
                </a:ext>
              </a:extLst>
            </p:cNvPr>
            <p:cNvSpPr txBox="1"/>
            <p:nvPr/>
          </p:nvSpPr>
          <p:spPr>
            <a:xfrm>
              <a:off x="7687201" y="19004480"/>
              <a:ext cx="130356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HMDM</a:t>
              </a:r>
            </a:p>
          </p:txBody>
        </p:sp>
        <p:cxnSp>
          <p:nvCxnSpPr>
            <p:cNvPr id="145" name="Straight Arrow Connector 144">
              <a:extLst>
                <a:ext uri="{FF2B5EF4-FFF2-40B4-BE49-F238E27FC236}">
                  <a16:creationId xmlns:a16="http://schemas.microsoft.com/office/drawing/2014/main" id="{1ED3780F-8D1E-22BA-BC80-65C19C97BF9E}"/>
                </a:ext>
              </a:extLst>
            </p:cNvPr>
            <p:cNvCxnSpPr>
              <a:cxnSpLocks/>
            </p:cNvCxnSpPr>
            <p:nvPr/>
          </p:nvCxnSpPr>
          <p:spPr>
            <a:xfrm>
              <a:off x="4453124" y="22968355"/>
              <a:ext cx="6404399" cy="2794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F478BB89-2790-E2FD-2C9D-1F8F879B48E5}"/>
                </a:ext>
              </a:extLst>
            </p:cNvPr>
            <p:cNvSpPr txBox="1"/>
            <p:nvPr/>
          </p:nvSpPr>
          <p:spPr>
            <a:xfrm>
              <a:off x="10880344" y="22750669"/>
              <a:ext cx="13051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</a:p>
          </p:txBody>
        </p:sp>
        <p:cxnSp>
          <p:nvCxnSpPr>
            <p:cNvPr id="147" name="Straight Arrow Connector 146">
              <a:extLst>
                <a:ext uri="{FF2B5EF4-FFF2-40B4-BE49-F238E27FC236}">
                  <a16:creationId xmlns:a16="http://schemas.microsoft.com/office/drawing/2014/main" id="{E87B3159-70CD-CB7C-4348-8DEB67F61F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75945" y="22287667"/>
              <a:ext cx="13708" cy="69466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B2B4E953-644F-0C78-319B-128339BB6A91}"/>
                </a:ext>
              </a:extLst>
            </p:cNvPr>
            <p:cNvSpPr txBox="1"/>
            <p:nvPr/>
          </p:nvSpPr>
          <p:spPr>
            <a:xfrm rot="16200000">
              <a:off x="3865551" y="21254359"/>
              <a:ext cx="13051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163</a:t>
              </a:r>
            </a:p>
          </p:txBody>
        </p: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5D4BA1D5-85CB-B8ED-D0DD-F5594E9C063B}"/>
                </a:ext>
              </a:extLst>
            </p:cNvPr>
            <p:cNvCxnSpPr>
              <a:cxnSpLocks/>
            </p:cNvCxnSpPr>
            <p:nvPr/>
          </p:nvCxnSpPr>
          <p:spPr>
            <a:xfrm>
              <a:off x="5017042" y="20724018"/>
              <a:ext cx="1752851" cy="0"/>
            </a:xfrm>
            <a:prstGeom prst="line">
              <a:avLst/>
            </a:prstGeom>
            <a:ln w="254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E573EA79-F6BC-F851-31A3-C02941019395}"/>
                </a:ext>
              </a:extLst>
            </p:cNvPr>
            <p:cNvCxnSpPr>
              <a:cxnSpLocks/>
            </p:cNvCxnSpPr>
            <p:nvPr/>
          </p:nvCxnSpPr>
          <p:spPr>
            <a:xfrm>
              <a:off x="7780045" y="20724018"/>
              <a:ext cx="1752851" cy="0"/>
            </a:xfrm>
            <a:prstGeom prst="line">
              <a:avLst/>
            </a:prstGeom>
            <a:ln w="254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2BEF081C-310C-8284-FCC8-A1582D6871A9}"/>
                </a:ext>
              </a:extLst>
            </p:cNvPr>
            <p:cNvCxnSpPr>
              <a:cxnSpLocks/>
            </p:cNvCxnSpPr>
            <p:nvPr/>
          </p:nvCxnSpPr>
          <p:spPr>
            <a:xfrm>
              <a:off x="10421460" y="20735614"/>
              <a:ext cx="1752851" cy="0"/>
            </a:xfrm>
            <a:prstGeom prst="line">
              <a:avLst/>
            </a:prstGeom>
            <a:ln w="254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1" name="TextBox 160">
            <a:extLst>
              <a:ext uri="{FF2B5EF4-FFF2-40B4-BE49-F238E27FC236}">
                <a16:creationId xmlns:a16="http://schemas.microsoft.com/office/drawing/2014/main" id="{A618443D-783E-703F-9BF3-3D697798927D}"/>
              </a:ext>
            </a:extLst>
          </p:cNvPr>
          <p:cNvSpPr txBox="1"/>
          <p:nvPr/>
        </p:nvSpPr>
        <p:spPr>
          <a:xfrm>
            <a:off x="7036479" y="7521963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4EDCF922-6F4E-0CC7-5C7E-236123574F3D}"/>
              </a:ext>
            </a:extLst>
          </p:cNvPr>
          <p:cNvSpPr txBox="1"/>
          <p:nvPr/>
        </p:nvSpPr>
        <p:spPr>
          <a:xfrm>
            <a:off x="16903177" y="7521963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BDD5ED-6214-7EF1-C805-7FD44B6F6464}"/>
              </a:ext>
            </a:extLst>
          </p:cNvPr>
          <p:cNvSpPr txBox="1"/>
          <p:nvPr/>
        </p:nvSpPr>
        <p:spPr>
          <a:xfrm>
            <a:off x="1124963" y="7521963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80ECE98-AF47-F4CD-6C83-5DA873A51D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172627"/>
              </p:ext>
            </p:extLst>
          </p:nvPr>
        </p:nvGraphicFramePr>
        <p:xfrm>
          <a:off x="1468438" y="9058275"/>
          <a:ext cx="4116387" cy="4665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7" imgW="2570289" imgH="2915087" progId="Prism6.Document">
                  <p:embed/>
                </p:oleObj>
              </mc:Choice>
              <mc:Fallback>
                <p:oleObj name="Prism 6" r:id="rId7" imgW="2570289" imgH="2915087" progId="Prism6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80ECE98-AF47-F4CD-6C83-5DA873A51D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68438" y="9058275"/>
                        <a:ext cx="4116387" cy="4665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21408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540</TotalTime>
  <Words>115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nak, Ahmet (kaynakat)</dc:creator>
  <cp:lastModifiedBy>Kaynak, Ahmet (kaynakat)</cp:lastModifiedBy>
  <cp:revision>77</cp:revision>
  <dcterms:created xsi:type="dcterms:W3CDTF">2021-11-16T17:09:50Z</dcterms:created>
  <dcterms:modified xsi:type="dcterms:W3CDTF">2025-01-27T17:21:13Z</dcterms:modified>
</cp:coreProperties>
</file>